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4" r:id="rId8"/>
    <p:sldId id="263" r:id="rId9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7495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943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118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3656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8654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4569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6636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0765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499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1356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2899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13049-2DDD-4ECE-8345-86CFCFE117AD}" type="datetimeFigureOut">
              <a:rPr lang="ko-KR" altLang="en-US" smtClean="0"/>
              <a:t>2021-09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58EA9-2E6A-4CEF-AC8B-C947381CD35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2379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3.png"/><Relationship Id="rId17" Type="http://schemas.microsoft.com/office/2007/relationships/hdphoto" Target="../media/hdphoto8.wdp"/><Relationship Id="rId2" Type="http://schemas.openxmlformats.org/officeDocument/2006/relationships/image" Target="../media/image8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12.png"/><Relationship Id="rId4" Type="http://schemas.openxmlformats.org/officeDocument/2006/relationships/image" Target="../media/image9.png"/><Relationship Id="rId9" Type="http://schemas.microsoft.com/office/2007/relationships/hdphoto" Target="../media/hdphoto4.wdp"/><Relationship Id="rId1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40058" y="1170432"/>
            <a:ext cx="6711885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. S1</a:t>
            </a:r>
          </a:p>
          <a:p>
            <a:pPr algn="ctr"/>
            <a:endParaRPr lang="en-US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TS knockdow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ME180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CaSki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5067228" y="2436464"/>
            <a:ext cx="2057545" cy="1902105"/>
            <a:chOff x="4278455" y="1494632"/>
            <a:chExt cx="2057545" cy="1902105"/>
          </a:xfrm>
        </p:grpSpPr>
        <p:grpSp>
          <p:nvGrpSpPr>
            <p:cNvPr id="12" name="Group 11"/>
            <p:cNvGrpSpPr/>
            <p:nvPr/>
          </p:nvGrpSpPr>
          <p:grpSpPr>
            <a:xfrm>
              <a:off x="5364000" y="1494636"/>
              <a:ext cx="972000" cy="1902101"/>
              <a:chOff x="5364000" y="1494636"/>
              <a:chExt cx="972000" cy="1902101"/>
            </a:xfrm>
          </p:grpSpPr>
          <p:pic>
            <p:nvPicPr>
              <p:cNvPr id="2" name="Picture 1"/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956" t="38064" r="47114" b="56626"/>
              <a:stretch/>
            </p:blipFill>
            <p:spPr>
              <a:xfrm>
                <a:off x="5364000" y="2664000"/>
                <a:ext cx="972000" cy="32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4" name="TextBox 3"/>
              <p:cNvSpPr txBox="1"/>
              <p:nvPr/>
            </p:nvSpPr>
            <p:spPr>
              <a:xfrm rot="16200000">
                <a:off x="5078628" y="1940014"/>
                <a:ext cx="11677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siRN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16200000">
                <a:off x="5616916" y="2054052"/>
                <a:ext cx="9396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S siRN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456303" y="3027405"/>
                <a:ext cx="7873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ki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4278455" y="1494632"/>
              <a:ext cx="972000" cy="1902105"/>
              <a:chOff x="7553001" y="1494632"/>
              <a:chExt cx="972000" cy="1902105"/>
            </a:xfrm>
          </p:grpSpPr>
          <p:sp>
            <p:nvSpPr>
              <p:cNvPr id="6" name="TextBox 5"/>
              <p:cNvSpPr txBox="1"/>
              <p:nvPr/>
            </p:nvSpPr>
            <p:spPr>
              <a:xfrm rot="16200000">
                <a:off x="7257541" y="1940010"/>
                <a:ext cx="11677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 siRN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6200000">
                <a:off x="7783472" y="2054048"/>
                <a:ext cx="9396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S siRN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7587596" y="3027405"/>
                <a:ext cx="9028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180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0" name="Picture 9"/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176" t="37474" r="39557" b="55447"/>
              <a:stretch/>
            </p:blipFill>
            <p:spPr>
              <a:xfrm>
                <a:off x="7553001" y="2664000"/>
                <a:ext cx="972000" cy="32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sp>
        <p:nvSpPr>
          <p:cNvPr id="14" name="Rectangle 13"/>
          <p:cNvSpPr/>
          <p:nvPr/>
        </p:nvSpPr>
        <p:spPr>
          <a:xfrm>
            <a:off x="3048000" y="4585707"/>
            <a:ext cx="6096000" cy="73866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  <a:spcAft>
                <a:spcPts val="1000"/>
              </a:spcAft>
            </a:pP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FTS silencing was performed as mentioned in the manuscript materials and methods section by treating the cells with 50 </a:t>
            </a:r>
            <a:r>
              <a:rPr lang="en-US" sz="14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nM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 of either scrambled siRNA or FTS siRNA.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500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78408" y="-25744"/>
            <a:ext cx="5892288" cy="1066959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. S2:</a:t>
            </a:r>
          </a:p>
          <a:p>
            <a:pPr>
              <a:spcAft>
                <a:spcPts val="10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adiation dose-dependent change in the expression of Notch molecules and FTS in ME180 and CaSki cells</a:t>
            </a:r>
            <a:r>
              <a:rPr lang="en-US" sz="1400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endParaRPr lang="en-US" sz="1400" b="1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78408" y="1984248"/>
            <a:ext cx="467258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s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	: not significant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	: 0.0329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	: 0.0017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	: 0.00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	: &lt;0.0001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1501" y="0"/>
            <a:ext cx="5550499" cy="685800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178408" y="1203883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each protein was calculated by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easurement using the Multi-Gauge ver. 3.1 Software (Fujifilm, Tokyo, Japan). Band densities of target proteins were normalized to actin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. The values thus obtained were used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plot the bar graph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9524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566588" y="204551"/>
            <a:ext cx="2971800" cy="46166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ose-dependent changes in the expression of 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-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omplex molecules </a:t>
            </a:r>
            <a:endParaRPr lang="en-US" sz="12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69264" y="216726"/>
            <a:ext cx="3638392" cy="128240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. S3:</a:t>
            </a:r>
          </a:p>
          <a:p>
            <a:pPr algn="just">
              <a:spcAft>
                <a:spcPts val="10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adiation dose and time-dependent change in the expression of </a:t>
            </a: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400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-</a:t>
            </a: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 molecules in ME180 and CaSki cells</a:t>
            </a:r>
            <a:endParaRPr lang="en-US" sz="1400" b="1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8533311" y="219791"/>
            <a:ext cx="2971800" cy="46166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ime-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endent changes in the expression of 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-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omplex molecules </a:t>
            </a:r>
            <a:endParaRPr lang="en-US" sz="12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5442" y="740664"/>
            <a:ext cx="4087538" cy="6120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5092" y="740664"/>
            <a:ext cx="3754792" cy="6120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69264" y="3273552"/>
            <a:ext cx="29671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s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	: not significant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	: &lt;0.05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	: &lt;0.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	: &lt;0.0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	: &lt;0.0001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69264" y="1715947"/>
            <a:ext cx="352866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each protein was calculated by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easurement using the Multi-Gauge ver. 3.1 Software (Fujifilm, Tokyo, Japan). Band densities of target proteins were normalized to actin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. The values thus obtained were used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plot the bar graph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459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82" y="658368"/>
            <a:ext cx="3548636" cy="612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1498" y="658368"/>
            <a:ext cx="3757551" cy="6120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69264" y="216726"/>
            <a:ext cx="3638392" cy="128240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. S4:</a:t>
            </a:r>
          </a:p>
          <a:p>
            <a:pPr algn="just">
              <a:spcAft>
                <a:spcPts val="10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fects of FTS silencing on Notch molecules and </a:t>
            </a: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-</a:t>
            </a: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 complex molecules expression in ME180 and CaSki cells</a:t>
            </a:r>
            <a:endParaRPr lang="en-US" sz="1400" b="1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69264" y="3273552"/>
            <a:ext cx="29671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s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	: not significant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	: &lt;0.05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	: &lt;0.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	: &lt;0.0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	: &lt;0.0001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69264" y="1715947"/>
            <a:ext cx="352866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each protein was calculated by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easurement using the Multi-Gauge ver. 3.1 Software (Fujifilm, Tokyo, Japan). Band densities of target proteins were normalized to actin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. The values thus obtained were used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plot the bar graphs.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4963900" y="204551"/>
            <a:ext cx="2971800" cy="46166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fects of FTS silencing on Notch molecules e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xpression </a:t>
            </a:r>
            <a:endParaRPr lang="en-US" sz="12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8754373" y="219791"/>
            <a:ext cx="2971800" cy="46166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fects of FTS silencing on </a:t>
            </a: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-</a:t>
            </a: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omplex molecules expression</a:t>
            </a:r>
            <a:endParaRPr lang="en-US" sz="12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9912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7064" y="594360"/>
            <a:ext cx="4135673" cy="6120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168395" y="216726"/>
            <a:ext cx="3638392" cy="128240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. S5:</a:t>
            </a:r>
          </a:p>
          <a:p>
            <a:pPr algn="just">
              <a:spcAft>
                <a:spcPts val="10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fects of FTS silencing on Notch molecules and </a:t>
            </a: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-</a:t>
            </a: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 complex molecules expression in spheroids of ME180 and CaSki cells</a:t>
            </a:r>
            <a:endParaRPr lang="en-US" sz="1400" b="1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168395" y="3273552"/>
            <a:ext cx="29671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s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	: not significant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	: &lt;0.05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	: &lt;0.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	: &lt;0.001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	: &lt;0.0001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168395" y="1715947"/>
            <a:ext cx="352866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each protein was calculated by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easurement using the Multi-Gauge ver. 3.1 Software (Fujifilm, Tokyo, Japan). Band densities of target proteins were normalized to actin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. The values thus obtained were used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plot the bar graphs.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6372472" y="158831"/>
            <a:ext cx="3682448" cy="46166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fects of FTS silencing on Notch 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olecules and </a:t>
            </a: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2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cretase complex molecules e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xpression in spheroids</a:t>
            </a:r>
            <a:endParaRPr lang="en-US" sz="12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25857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81058" y="286265"/>
            <a:ext cx="11892762" cy="6567772"/>
            <a:chOff x="-176192" y="163725"/>
            <a:chExt cx="11892762" cy="6567772"/>
          </a:xfrm>
        </p:grpSpPr>
        <p:grpSp>
          <p:nvGrpSpPr>
            <p:cNvPr id="18" name="Group 17"/>
            <p:cNvGrpSpPr/>
            <p:nvPr/>
          </p:nvGrpSpPr>
          <p:grpSpPr>
            <a:xfrm>
              <a:off x="-176192" y="163725"/>
              <a:ext cx="6213723" cy="6528028"/>
              <a:chOff x="-156314" y="163725"/>
              <a:chExt cx="6213723" cy="6528028"/>
            </a:xfrm>
          </p:grpSpPr>
          <p:grpSp>
            <p:nvGrpSpPr>
              <p:cNvPr id="32" name="Group 31"/>
              <p:cNvGrpSpPr/>
              <p:nvPr/>
            </p:nvGrpSpPr>
            <p:grpSpPr>
              <a:xfrm rot="16200000">
                <a:off x="9804" y="644148"/>
                <a:ext cx="6141706" cy="5953504"/>
                <a:chOff x="-96643" y="310499"/>
                <a:chExt cx="6141706" cy="5953504"/>
              </a:xfrm>
            </p:grpSpPr>
            <p:pic>
              <p:nvPicPr>
                <p:cNvPr id="39" name="Picture 38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aturation sat="0"/>
                          </a14:imgEffect>
                          <a14:imgEffect>
                            <a14:brightnessContrast bright="20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674" t="8925" r="35407" b="8662"/>
                <a:stretch/>
              </p:blipFill>
              <p:spPr>
                <a:xfrm>
                  <a:off x="4605063" y="611925"/>
                  <a:ext cx="1440000" cy="5652000"/>
                </a:xfrm>
                <a:prstGeom prst="rect">
                  <a:avLst/>
                </a:prstGeom>
              </p:spPr>
            </p:pic>
            <p:pic>
              <p:nvPicPr>
                <p:cNvPr id="40" name="Picture 39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aturation sat="0"/>
                          </a14:imgEffect>
                          <a14:imgEffect>
                            <a14:brightnessContrast bright="20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615" t="8925" r="31721" b="8658"/>
                <a:stretch/>
              </p:blipFill>
              <p:spPr>
                <a:xfrm>
                  <a:off x="3135241" y="612003"/>
                  <a:ext cx="1440000" cy="5652000"/>
                </a:xfrm>
                <a:prstGeom prst="rect">
                  <a:avLst/>
                </a:prstGeom>
              </p:spPr>
            </p:pic>
            <p:pic>
              <p:nvPicPr>
                <p:cNvPr id="41" name="Picture 40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aturation sat="0"/>
                          </a14:imgEffect>
                          <a14:imgEffect>
                            <a14:brightnessContrast bright="20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161" t="12337" r="33174" b="5252"/>
                <a:stretch/>
              </p:blipFill>
              <p:spPr>
                <a:xfrm>
                  <a:off x="1646829" y="611928"/>
                  <a:ext cx="1440000" cy="5652000"/>
                </a:xfrm>
                <a:prstGeom prst="rect">
                  <a:avLst/>
                </a:prstGeom>
              </p:spPr>
            </p:pic>
            <p:pic>
              <p:nvPicPr>
                <p:cNvPr id="42" name="Picture 41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0"/>
                          </a14:imgEffect>
                          <a14:imgEffect>
                            <a14:brightnessContrast bright="20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5202" t="11550" r="145" b="6039"/>
                <a:stretch/>
              </p:blipFill>
              <p:spPr>
                <a:xfrm>
                  <a:off x="177004" y="611931"/>
                  <a:ext cx="1440000" cy="5652000"/>
                </a:xfrm>
                <a:prstGeom prst="rect">
                  <a:avLst/>
                </a:prstGeom>
              </p:spPr>
            </p:pic>
            <p:grpSp>
              <p:nvGrpSpPr>
                <p:cNvPr id="43" name="Group 42"/>
                <p:cNvGrpSpPr/>
                <p:nvPr/>
              </p:nvGrpSpPr>
              <p:grpSpPr>
                <a:xfrm>
                  <a:off x="-96643" y="310499"/>
                  <a:ext cx="6088606" cy="5553967"/>
                  <a:chOff x="-96643" y="310499"/>
                  <a:chExt cx="6088606" cy="5553967"/>
                </a:xfrm>
              </p:grpSpPr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4680387" y="310503"/>
                    <a:ext cx="1311576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 siRNA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3325042" y="310580"/>
                    <a:ext cx="1099981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TS siRNA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1734662" y="310499"/>
                    <a:ext cx="1311576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 siRNA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355773" y="310503"/>
                    <a:ext cx="1099981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TS siRNA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 rot="5400000">
                    <a:off x="-217349" y="1188126"/>
                    <a:ext cx="56457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 rot="5400000">
                    <a:off x="-289479" y="2582917"/>
                    <a:ext cx="708848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.5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 rot="5400000">
                    <a:off x="-217344" y="3947890"/>
                    <a:ext cx="56457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 rot="5400000">
                    <a:off x="-265434" y="5372505"/>
                    <a:ext cx="66075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cxnSp>
            <p:nvCxnSpPr>
              <p:cNvPr id="33" name="Straight Connector 32"/>
              <p:cNvCxnSpPr/>
              <p:nvPr/>
            </p:nvCxnSpPr>
            <p:spPr>
              <a:xfrm>
                <a:off x="468367" y="484733"/>
                <a:ext cx="55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2976389" y="163725"/>
                <a:ext cx="633507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-ray</a:t>
                </a:r>
                <a:endParaRPr 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>
                <a:off x="-315280" y="4816506"/>
                <a:ext cx="654345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Ski</a:t>
                </a:r>
                <a:endParaRPr 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>
                <a:off x="137751" y="3508265"/>
                <a:ext cx="0" cy="28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 rot="16200000">
                <a:off x="-375605" y="1853976"/>
                <a:ext cx="761747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180</a:t>
                </a:r>
                <a:endParaRPr 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8" name="Straight Connector 37"/>
              <p:cNvCxnSpPr/>
              <p:nvPr/>
            </p:nvCxnSpPr>
            <p:spPr>
              <a:xfrm>
                <a:off x="131127" y="565613"/>
                <a:ext cx="0" cy="28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" name="Group 18"/>
            <p:cNvGrpSpPr/>
            <p:nvPr/>
          </p:nvGrpSpPr>
          <p:grpSpPr>
            <a:xfrm>
              <a:off x="6064570" y="163725"/>
              <a:ext cx="5652000" cy="6567772"/>
              <a:chOff x="6502720" y="163725"/>
              <a:chExt cx="5652000" cy="6567772"/>
            </a:xfrm>
          </p:grpSpPr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10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161" t="11547" r="33174" b="6054"/>
              <a:stretch/>
            </p:blipFill>
            <p:spPr>
              <a:xfrm rot="16200000">
                <a:off x="8608720" y="1403739"/>
                <a:ext cx="1440000" cy="5652000"/>
              </a:xfrm>
              <a:prstGeom prst="rect">
                <a:avLst/>
              </a:prstGeom>
            </p:spPr>
          </p:pic>
          <p:grpSp>
            <p:nvGrpSpPr>
              <p:cNvPr id="21" name="Group 20"/>
              <p:cNvGrpSpPr/>
              <p:nvPr/>
            </p:nvGrpSpPr>
            <p:grpSpPr>
              <a:xfrm>
                <a:off x="6574295" y="163725"/>
                <a:ext cx="5508000" cy="6567772"/>
                <a:chOff x="468367" y="163725"/>
                <a:chExt cx="5508000" cy="6567772"/>
              </a:xfrm>
            </p:grpSpPr>
            <p:grpSp>
              <p:nvGrpSpPr>
                <p:cNvPr id="25" name="Group 24"/>
                <p:cNvGrpSpPr/>
                <p:nvPr/>
              </p:nvGrpSpPr>
              <p:grpSpPr>
                <a:xfrm rot="16200000">
                  <a:off x="3073710" y="4195438"/>
                  <a:ext cx="323167" cy="4748952"/>
                  <a:chOff x="-136396" y="1067422"/>
                  <a:chExt cx="323167" cy="4748952"/>
                </a:xfrm>
              </p:grpSpPr>
              <p:sp>
                <p:nvSpPr>
                  <p:cNvPr id="28" name="TextBox 27"/>
                  <p:cNvSpPr txBox="1"/>
                  <p:nvPr/>
                </p:nvSpPr>
                <p:spPr>
                  <a:xfrm rot="5400000">
                    <a:off x="-257101" y="1188128"/>
                    <a:ext cx="56457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 rot="5400000">
                    <a:off x="-257102" y="2582920"/>
                    <a:ext cx="56457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 rot="5400000">
                    <a:off x="-257101" y="3947890"/>
                    <a:ext cx="56457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 rot="5400000">
                    <a:off x="-257100" y="5372503"/>
                    <a:ext cx="564577" cy="3231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</a:t>
                    </a:r>
                    <a:r>
                      <a:rPr lang="en-US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sz="15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y</a:t>
                    </a:r>
                    <a:endParaRPr lang="en-US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26" name="Straight Connector 25"/>
                <p:cNvCxnSpPr/>
                <p:nvPr/>
              </p:nvCxnSpPr>
              <p:spPr>
                <a:xfrm>
                  <a:off x="468367" y="494672"/>
                  <a:ext cx="55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26"/>
                <p:cNvSpPr txBox="1"/>
                <p:nvPr/>
              </p:nvSpPr>
              <p:spPr>
                <a:xfrm>
                  <a:off x="2938289" y="163725"/>
                  <a:ext cx="622286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5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-ion</a:t>
                  </a:r>
                  <a:endParaRPr 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12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809" t="11348" r="33528" b="6235"/>
              <a:stretch/>
            </p:blipFill>
            <p:spPr>
              <a:xfrm rot="16200000">
                <a:off x="8608720" y="2872635"/>
                <a:ext cx="1440000" cy="5652000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>
                <a:picLocks noChangeAspect="1"/>
              </p:cNvPicPr>
              <p:nvPr/>
            </p:nvPicPr>
            <p:blipFill rotWithShape="1">
              <a:blip r:embed="rId14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072" t="11287" r="33069" b="6302"/>
              <a:stretch/>
            </p:blipFill>
            <p:spPr>
              <a:xfrm rot="16200000">
                <a:off x="8608720" y="-1556349"/>
                <a:ext cx="1440000" cy="5652000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1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19" t="10500" r="35059" b="7083"/>
              <a:stretch/>
            </p:blipFill>
            <p:spPr>
              <a:xfrm rot="16200000">
                <a:off x="8608720" y="-87454"/>
                <a:ext cx="1440000" cy="5652000"/>
              </a:xfrm>
              <a:prstGeom prst="rect">
                <a:avLst/>
              </a:prstGeom>
            </p:spPr>
          </p:pic>
        </p:grpSp>
      </p:grpSp>
      <p:sp>
        <p:nvSpPr>
          <p:cNvPr id="52" name="TextBox 51"/>
          <p:cNvSpPr txBox="1"/>
          <p:nvPr/>
        </p:nvSpPr>
        <p:spPr>
          <a:xfrm>
            <a:off x="0" y="0"/>
            <a:ext cx="7549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: images of the colony formation assay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4557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/>
          <p:nvPr/>
        </p:nvSpPr>
        <p:spPr>
          <a:xfrm>
            <a:off x="236958" y="180243"/>
            <a:ext cx="3638392" cy="85151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. 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7:</a:t>
            </a:r>
            <a:endParaRPr lang="en-US" b="1" dirty="0" smtClean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spcAft>
                <a:spcPts val="10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ull blots of notch1 and cleaved notch1</a:t>
            </a:r>
            <a:endParaRPr lang="en-US" sz="1400" b="1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002" y="1788291"/>
            <a:ext cx="5299556" cy="2317179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6469" y="1788291"/>
            <a:ext cx="7459145" cy="43445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29383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1685" y="1085897"/>
            <a:ext cx="3345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T1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8732" y="1826549"/>
            <a:ext cx="7912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culation of dose modifying factor (DMF) at 10% surviving fraction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0495160"/>
              </p:ext>
            </p:extLst>
          </p:nvPr>
        </p:nvGraphicFramePr>
        <p:xfrm>
          <a:off x="454820" y="2399899"/>
          <a:ext cx="7872361" cy="1800000"/>
        </p:xfrm>
        <a:graphic>
          <a:graphicData uri="http://schemas.openxmlformats.org/drawingml/2006/table">
            <a:tbl>
              <a:tblPr/>
              <a:tblGrid>
                <a:gridCol w="1211436">
                  <a:extLst>
                    <a:ext uri="{9D8B030D-6E8A-4147-A177-3AD203B41FA5}">
                      <a16:colId xmlns:a16="http://schemas.microsoft.com/office/drawing/2014/main" xmlns="" val="800698621"/>
                    </a:ext>
                  </a:extLst>
                </a:gridCol>
                <a:gridCol w="1555270">
                  <a:extLst>
                    <a:ext uri="{9D8B030D-6E8A-4147-A177-3AD203B41FA5}">
                      <a16:colId xmlns:a16="http://schemas.microsoft.com/office/drawing/2014/main" xmlns="" val="3645374480"/>
                    </a:ext>
                  </a:extLst>
                </a:gridCol>
                <a:gridCol w="1173252">
                  <a:extLst>
                    <a:ext uri="{9D8B030D-6E8A-4147-A177-3AD203B41FA5}">
                      <a16:colId xmlns:a16="http://schemas.microsoft.com/office/drawing/2014/main" xmlns="" val="2546379542"/>
                    </a:ext>
                  </a:extLst>
                </a:gridCol>
                <a:gridCol w="1193437">
                  <a:extLst>
                    <a:ext uri="{9D8B030D-6E8A-4147-A177-3AD203B41FA5}">
                      <a16:colId xmlns:a16="http://schemas.microsoft.com/office/drawing/2014/main" xmlns="" val="3100523227"/>
                    </a:ext>
                  </a:extLst>
                </a:gridCol>
                <a:gridCol w="1347036">
                  <a:extLst>
                    <a:ext uri="{9D8B030D-6E8A-4147-A177-3AD203B41FA5}">
                      <a16:colId xmlns:a16="http://schemas.microsoft.com/office/drawing/2014/main" xmlns="" val="3147823343"/>
                    </a:ext>
                  </a:extLst>
                </a:gridCol>
                <a:gridCol w="1391930">
                  <a:extLst>
                    <a:ext uri="{9D8B030D-6E8A-4147-A177-3AD203B41FA5}">
                      <a16:colId xmlns:a16="http://schemas.microsoft.com/office/drawing/2014/main" xmlns="" val="1640577777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18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ki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83438824"/>
                  </a:ext>
                </a:extLst>
              </a:tr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-ra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-ion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-ra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-ion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96706062"/>
                  </a:ext>
                </a:extLst>
              </a:tr>
              <a:tr h="3600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diation dose </a:t>
                      </a:r>
                      <a:r>
                        <a:rPr lang="en-US" altLang="ko-KR" sz="14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Gy)</a:t>
                      </a:r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or SF</a:t>
                      </a:r>
                      <a:r>
                        <a:rPr lang="en-US" sz="1400" b="1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  <a:endParaRPr lang="en-US" sz="1400" b="1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Control siRN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700 (a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820 (c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420 (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10 (g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84234552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TS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RNA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00 (b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627 (d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480 (f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00 (h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9942098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DMF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93 (a/b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118 (c/d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172 (e/f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95 (g/h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17671159"/>
                  </a:ext>
                </a:extLst>
              </a:tr>
            </a:tbl>
          </a:graphicData>
        </a:graphic>
      </p:graphicFrame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4284859"/>
              </p:ext>
            </p:extLst>
          </p:nvPr>
        </p:nvGraphicFramePr>
        <p:xfrm>
          <a:off x="2276670" y="5037854"/>
          <a:ext cx="4301412" cy="890905"/>
        </p:xfrm>
        <a:graphic>
          <a:graphicData uri="http://schemas.openxmlformats.org/drawingml/2006/table">
            <a:tbl>
              <a:tblPr/>
              <a:tblGrid>
                <a:gridCol w="905069"/>
                <a:gridCol w="699796"/>
                <a:gridCol w="1035698"/>
                <a:gridCol w="849085"/>
                <a:gridCol w="811764"/>
              </a:tblGrid>
              <a:tr h="18351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lculated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-ion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B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hange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BE under the</a:t>
                      </a:r>
                    </a:p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fluence of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TS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iRN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E1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Sk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E1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Sk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3515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582 (a/c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664 (e/g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ontro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889 (a/d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918 (e/h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3515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643 ((b/d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491 (f/h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FT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iR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03733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572</Words>
  <Application>Microsoft Office PowerPoint</Application>
  <PresentationFormat>와이드스크린</PresentationFormat>
  <Paragraphs>112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6" baseType="lpstr">
      <vt:lpstr>Mangal</vt:lpstr>
      <vt:lpstr>맑은 고딕</vt:lpstr>
      <vt:lpstr>맑은 고딕</vt:lpstr>
      <vt:lpstr>Arial</vt:lpstr>
      <vt:lpstr>Calibri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istrator</dc:creator>
  <cp:lastModifiedBy>Administrator</cp:lastModifiedBy>
  <cp:revision>6</cp:revision>
  <dcterms:created xsi:type="dcterms:W3CDTF">2021-08-25T11:22:13Z</dcterms:created>
  <dcterms:modified xsi:type="dcterms:W3CDTF">2021-09-17T10:17:47Z</dcterms:modified>
</cp:coreProperties>
</file>